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6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39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105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517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309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494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894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945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539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117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469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828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469CB-9E85-4957-A21C-B772A102B461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E97AE-2EED-4051-B540-90F295CD0C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433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275440" y="280639"/>
            <a:ext cx="8051820" cy="27830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latin typeface="Times New Roman" pitchFamily="18" charset="0"/>
                <a:cs typeface="Times New Roman" pitchFamily="18" charset="0"/>
              </a:rPr>
              <a:t>Applied Microbiology and Biotechnology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Express</a:t>
            </a:r>
            <a:endParaRPr lang="en-IN" sz="1200" b="1" i="1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N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1200" b="1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esium and strontium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olerant </a:t>
            </a:r>
            <a:r>
              <a:rPr lang="en-US" sz="1200" b="1" i="1" dirty="0" err="1">
                <a:latin typeface="Times New Roman" pitchFamily="18" charset="0"/>
                <a:cs typeface="Times New Roman" pitchFamily="18" charset="0"/>
              </a:rPr>
              <a:t>Arthrobacte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sp. strain KMSZP6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isolated from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 pristine uranium ore deposit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15000"/>
              </a:lnSpc>
              <a:tabLst>
                <a:tab pos="457200" algn="l"/>
              </a:tabLst>
            </a:pP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Pynskhem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Bok Swer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Santa Ram Joshi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Celin Acharya*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2, 3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100" dirty="0">
                <a:solidFill>
                  <a:srgbClr val="00000A"/>
                </a:solidFill>
                <a:ea typeface="Calibri"/>
                <a:cs typeface="Times New Roman"/>
              </a:rPr>
              <a:t> 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Department of Biotechnology and Bioinformatics, North Eastern Hill University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Umshi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Mawlai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Shillo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- 793022, India  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2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Molecular Biology Division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 Atomic Research Centre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Trombay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, Mumbai 400085, India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3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Homi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tional Institute,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Anushakti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gar, Mumbai, 400094, India</a:t>
            </a:r>
            <a:r>
              <a:rPr lang="en-US" sz="1200" b="1" dirty="0">
                <a:solidFill>
                  <a:srgbClr val="00000A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           </a:t>
            </a:r>
            <a:endParaRPr lang="en-US" sz="1100" dirty="0">
              <a:solidFill>
                <a:srgbClr val="00000A"/>
              </a:solidFill>
              <a:latin typeface="Times New Roman" pitchFamily="18" charset="0"/>
              <a:ea typeface="Calibri"/>
              <a:cs typeface="Times New Roman" pitchFamily="18" charset="0"/>
            </a:endParaRPr>
          </a:p>
        </p:txBody>
      </p:sp>
      <p:sp>
        <p:nvSpPr>
          <p:cNvPr id="5" name="Rectangle 5"/>
          <p:cNvSpPr>
            <a:spLocks noChangeArrowheads="1"/>
          </p:cNvSpPr>
          <p:nvPr/>
        </p:nvSpPr>
        <p:spPr bwMode="auto">
          <a:xfrm>
            <a:off x="308097" y="4191000"/>
            <a:ext cx="4438074" cy="1384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/>
            </a:r>
            <a:b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</a:b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* Corresponding author,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iling address: Molecular Biology Division,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habh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tomic Research Centre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ombay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Mumbai 400 085, India.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hone: +(91)22  25592256, E-mail: celin@barc.gov.in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95582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838200" y="-152400"/>
            <a:ext cx="3598863" cy="7135813"/>
            <a:chOff x="1506537" y="-174625"/>
            <a:chExt cx="3598863" cy="7135813"/>
          </a:xfrm>
        </p:grpSpPr>
        <p:grpSp>
          <p:nvGrpSpPr>
            <p:cNvPr id="2" name="Group 1"/>
            <p:cNvGrpSpPr/>
            <p:nvPr/>
          </p:nvGrpSpPr>
          <p:grpSpPr>
            <a:xfrm>
              <a:off x="1506537" y="-174625"/>
              <a:ext cx="3598863" cy="7135813"/>
              <a:chOff x="1447800" y="-174625"/>
              <a:chExt cx="3598863" cy="7135813"/>
            </a:xfrm>
          </p:grpSpPr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68343931"/>
                  </p:ext>
                </p:extLst>
              </p:nvPr>
            </p:nvGraphicFramePr>
            <p:xfrm>
              <a:off x="1465263" y="2045608"/>
              <a:ext cx="3581400" cy="27432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83" name="Graph" r:id="rId3" imgW="3901320" imgH="2986920" progId="Origin50.Graph">
                      <p:embed/>
                    </p:oleObj>
                  </mc:Choice>
                  <mc:Fallback>
                    <p:oleObj name="Graph" r:id="rId3" imgW="3901320" imgH="2986920" progId="Origin50.Graph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465263" y="2045608"/>
                            <a:ext cx="3581400" cy="2743200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48718489"/>
                  </p:ext>
                </p:extLst>
              </p:nvPr>
            </p:nvGraphicFramePr>
            <p:xfrm>
              <a:off x="1447800" y="4217988"/>
              <a:ext cx="3581400" cy="27432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84" name="Graph" r:id="rId5" imgW="3901320" imgH="2986920" progId="Origin50.Graph">
                      <p:embed/>
                    </p:oleObj>
                  </mc:Choice>
                  <mc:Fallback>
                    <p:oleObj name="Graph" r:id="rId5" imgW="3901320" imgH="2986920" progId="Origin50.Graph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6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447800" y="4217988"/>
                            <a:ext cx="3581400" cy="2743200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ject 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051261611"/>
                  </p:ext>
                </p:extLst>
              </p:nvPr>
            </p:nvGraphicFramePr>
            <p:xfrm>
              <a:off x="1465263" y="-174625"/>
              <a:ext cx="3581400" cy="27432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85" name="Graph" r:id="rId7" imgW="3901440" imgH="2987040" progId="Origin50.Graph">
                      <p:embed/>
                    </p:oleObj>
                  </mc:Choice>
                  <mc:Fallback>
                    <p:oleObj name="Graph" r:id="rId7" imgW="3901440" imgH="2987040" progId="Origin50.Graph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8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465263" y="-174625"/>
                            <a:ext cx="3581400" cy="2743200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7" name="TextBox 6"/>
            <p:cNvSpPr txBox="1"/>
            <p:nvPr/>
          </p:nvSpPr>
          <p:spPr>
            <a:xfrm>
              <a:off x="2242454" y="348336"/>
              <a:ext cx="7328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08796" y="2631325"/>
              <a:ext cx="9348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 smtClean="0">
                  <a:latin typeface="Arial" pitchFamily="34" charset="0"/>
                  <a:cs typeface="Arial" pitchFamily="34" charset="0"/>
                </a:rPr>
                <a:t>Cs treated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242458" y="4735284"/>
              <a:ext cx="9012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 err="1" smtClean="0">
                  <a:latin typeface="Arial" pitchFamily="34" charset="0"/>
                  <a:cs typeface="Arial" pitchFamily="34" charset="0"/>
                </a:rPr>
                <a:t>Sr</a:t>
              </a:r>
              <a:r>
                <a:rPr lang="en-IN" sz="1200" b="1" dirty="0" smtClean="0">
                  <a:latin typeface="Arial" pitchFamily="34" charset="0"/>
                  <a:cs typeface="Arial" pitchFamily="34" charset="0"/>
                </a:rPr>
                <a:t> treated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" name="Rectangle 10"/>
          <p:cNvSpPr/>
          <p:nvPr/>
        </p:nvSpPr>
        <p:spPr>
          <a:xfrm>
            <a:off x="4267200" y="838200"/>
            <a:ext cx="4572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S4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DXRF spectra of control, unexposed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Arthrobacter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ells or cells exposed to either 75 mM Cs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o achieve a loading of 8544 mg g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-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dry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w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n 24 h or 75 mM  Sr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2+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o achieve a loading of 9464 mg g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-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dry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w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n 24h. The peaks corresponding to Cs K</a:t>
            </a:r>
            <a:r>
              <a:rPr lang="en-US" sz="1200" baseline="-25000" dirty="0" smtClean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d K</a:t>
            </a:r>
            <a:r>
              <a:rPr lang="en-US" sz="1200" baseline="-25000" dirty="0" smtClean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X-rays were seen at 30.6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keV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d 34.9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keV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espectively while those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r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K</a:t>
            </a:r>
            <a:r>
              <a:rPr lang="en-US" sz="1200" baseline="-25000" dirty="0" smtClean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d K</a:t>
            </a:r>
            <a:r>
              <a:rPr lang="en-US" sz="1200" baseline="-25000" dirty="0" smtClean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X-rays were observed at 14.2 and 15.8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keV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espectively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02205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23</Words>
  <Application>Microsoft Office PowerPoint</Application>
  <PresentationFormat>On-screen Show 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Graph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lin</dc:creator>
  <cp:lastModifiedBy>Celin</cp:lastModifiedBy>
  <cp:revision>9</cp:revision>
  <dcterms:created xsi:type="dcterms:W3CDTF">2016-03-04T08:26:09Z</dcterms:created>
  <dcterms:modified xsi:type="dcterms:W3CDTF">2016-08-29T07:24:13Z</dcterms:modified>
</cp:coreProperties>
</file>